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D8467EC-DBEB-4C00-830D-7829FDA72E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E1600E0-0A69-444D-BF2C-EC456D4EA4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A56B415-E25C-4C0A-B280-490BDD3F6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AD5DF96-2D87-48A0-8279-CE59A41B2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741EC5A-DD27-4AC4-B57E-44E71E142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9528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BB7F4CA-DF06-46CF-A8A0-7BE66A4530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7CBA3EC-0CBC-4416-A988-1FDE346753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E98E07D-696A-4E1D-916F-3E6C815DA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8CDE863-E455-46B9-AE58-69A4966E7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E003E57-8046-494B-8F17-71E91C484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4961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B4B10CC-6326-4761-A53B-C18558FEDA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C1D7839-A9B4-4EFF-92E6-1D3F9209A3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75B2AE0-09DA-4E1E-9F77-CA2F36E9E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56207D-A040-4614-A8C2-B982FCA84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8083F35-AFC1-4042-8A96-44347C6CE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8158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59614B7-1465-4679-82B8-72AD21FACD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F3A0B04-49B9-41C4-93AC-8BC53C10EE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F4A7C3B-C488-4881-A84C-2178459DE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B64CC61-9EAA-4ECD-A9C5-0264B9382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6F8980C-240E-47A6-A112-597F657A0F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530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6ACD6DA-6758-403F-AE71-E5EA59A78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C96F437-BC3B-4E2B-A4F1-EC8980E7BC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93AFD51-1890-4429-AB60-4123D3F78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83FE4DB-712C-4AD3-963E-72250299D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A965724-7E8F-470D-9DF9-325A00EAAC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42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BA2030D-CF06-4D12-BC91-9B255F30B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9D1AEA7-DAD0-45DA-8597-3BB4841DCE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773F742-D37E-480A-956C-8C9372DC94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2FAEC08-4711-4E32-9BBF-11CDF6068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E8C9F63-291E-480A-992F-F89330A4B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6592A96-F7C6-4615-BB96-740275CA2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60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0946B10-17D2-40F8-9253-56C7ED5FBD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7F14832-7E8A-48D8-B75C-B8C6591CB6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87FB4D3-C0F4-4601-8C19-E34CC605FE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8E0FCBA8-3520-42A8-AEB8-C1EA29E75F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D98C42FC-56D1-47DA-B262-133E527CED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C83FD3D-46A9-4B84-B25B-091705161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FE46BF2-0A5B-400A-8AF7-70129D0AB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A91231D-3F5D-49F0-91F8-05C2EBA0D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2810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26D5C68-0AA0-4B40-AEF0-5927C03EA0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C1D15F1-73B7-4946-AF5F-660983AA2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F81E4E8-5632-4168-AAF7-7E944ACEC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2199D89-E365-446C-88E6-7969CC3DB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4180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B4B7B039-989B-4D36-8659-E69813221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9B01861-105D-4AFB-802C-58BD43FE7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AF2AD9FF-A5FD-471E-B5C4-05CC17381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4898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5FB739C-BB60-44E3-A67E-A3BBDE7EA3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DBD27A3-1D19-4F2F-9466-C388ED8A13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628950E-8F7D-4BF4-ABB2-59856A0E5C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52BC1E5-847E-4A57-BAA8-111B1166C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A6F051A-CFEE-430D-AFAE-1F69F181F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7791AF8-E5C9-4B91-AF89-71D800272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1930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1CCBF0-4966-45C9-8F4A-5AA8F27780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D5349BC-1594-42EA-A4DB-603724BBA0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448A308-0064-455E-A4B4-1C34C33852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FA1D80D-040E-40BC-BD3B-1483F191D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2330F52-7169-41C1-84C9-A8E6AB719B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81E7E1C-C9B4-4FA6-8EBC-F1F40B154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8008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E7E5015-DD8C-4B0D-924E-657CDEAEAC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CC5A168-8765-4810-82D6-F909AE1484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718C4B7-24D8-49F2-8355-73AE3AF38F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D639C-5812-43ED-AB17-4CF0F3B2E5D4}" type="datetimeFigureOut">
              <a:rPr lang="ko-KR" altLang="en-US" smtClean="0"/>
              <a:t>2022-03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3970CF4-6057-4EF5-923B-E985AB4FDD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2D2FB6B-C6BD-464C-B7C8-F54AF70C9B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FDD37-F2B4-4D11-AEF6-9976AB712F5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1067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그림 25">
            <a:extLst>
              <a:ext uri="{FF2B5EF4-FFF2-40B4-BE49-F238E27FC236}">
                <a16:creationId xmlns:a16="http://schemas.microsoft.com/office/drawing/2014/main" id="{2082CAE3-5D3E-4823-A6C6-F60C4ADAEC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7860" y="777010"/>
            <a:ext cx="4700423" cy="265199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6A24647-05FB-4EA5-AFB8-DC45FCE1F524}"/>
              </a:ext>
            </a:extLst>
          </p:cNvPr>
          <p:cNvSpPr txBox="1"/>
          <p:nvPr/>
        </p:nvSpPr>
        <p:spPr>
          <a:xfrm>
            <a:off x="884599" y="4085256"/>
            <a:ext cx="10585764" cy="11666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lnSpc>
                <a:spcPct val="150000"/>
              </a:lnSpc>
            </a:pP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Supplementary information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algn="just" latinLnBrk="1">
              <a:lnSpc>
                <a:spcPct val="150000"/>
              </a:lnSpc>
            </a:pP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Additional file 1.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Detection of genes related to biogenic amine production. Lane M - 1 kb DNA marker, lane 1 -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맑은 고딕" panose="020B0503020000020004" pitchFamily="50" charset="-127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negative control with no template (</a:t>
            </a:r>
            <a:r>
              <a:rPr lang="en-US" altLang="ko-KR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hdc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; encoding histidine decarboxylase), lane 2 - positive control (</a:t>
            </a:r>
            <a:r>
              <a:rPr lang="en-US" altLang="ko-KR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hdc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), lane 3 - </a:t>
            </a:r>
            <a:r>
              <a:rPr lang="en-US" altLang="ko-KR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T. </a:t>
            </a:r>
            <a:r>
              <a:rPr lang="en-US" altLang="ko-KR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halophilus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EFEL7002 (</a:t>
            </a:r>
            <a:r>
              <a:rPr lang="en-US" altLang="ko-KR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hdc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), lane 4 - negative control with no template (</a:t>
            </a:r>
            <a:r>
              <a:rPr lang="en-US" altLang="ko-KR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tyrdc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; encoding tyrosine decarboxylase), lane 5 - positive control (</a:t>
            </a:r>
            <a:r>
              <a:rPr lang="en-US" altLang="ko-KR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tyrdc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), lane 6 - </a:t>
            </a:r>
            <a:r>
              <a:rPr lang="en-US" altLang="ko-KR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T. </a:t>
            </a:r>
            <a:r>
              <a:rPr lang="en-US" altLang="ko-KR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halophilus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EFEL7002 (</a:t>
            </a:r>
            <a:r>
              <a:rPr lang="en-US" altLang="ko-KR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tyrdc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), lane X – samples not discussed in the paper.</a:t>
            </a:r>
            <a:endParaRPr lang="ko-KR" altLang="ko-KR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6586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99</Words>
  <Application>Microsoft Office PowerPoint</Application>
  <PresentationFormat>와이드스크린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다혜</dc:creator>
  <cp:lastModifiedBy>김슬아</cp:lastModifiedBy>
  <cp:revision>7</cp:revision>
  <dcterms:created xsi:type="dcterms:W3CDTF">2022-02-28T09:21:47Z</dcterms:created>
  <dcterms:modified xsi:type="dcterms:W3CDTF">2022-03-08T00:44:03Z</dcterms:modified>
</cp:coreProperties>
</file>